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040313" cy="3441700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79C92E-7993-4B85-B149-D614864811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50560" y="138240"/>
            <a:ext cx="4538520" cy="5745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50560" y="802800"/>
            <a:ext cx="45385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50560" y="1989720"/>
            <a:ext cx="45385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C04A7C-AF49-4E3A-90AD-BBDBEBD60A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50560" y="138240"/>
            <a:ext cx="4538520" cy="5745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50560" y="802800"/>
            <a:ext cx="22147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576520" y="802800"/>
            <a:ext cx="22147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50560" y="1989720"/>
            <a:ext cx="22147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576520" y="1989720"/>
            <a:ext cx="22147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5ED6E6-109A-466C-AC05-D16B03D91F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50560" y="138240"/>
            <a:ext cx="4538520" cy="5745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50560" y="802800"/>
            <a:ext cx="146124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785240" y="802800"/>
            <a:ext cx="146124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319920" y="802800"/>
            <a:ext cx="146124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50560" y="1989720"/>
            <a:ext cx="146124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785240" y="1989720"/>
            <a:ext cx="146124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319920" y="1989720"/>
            <a:ext cx="146124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41F60B-9A6F-457B-B719-B6192BE36B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50560" y="138240"/>
            <a:ext cx="4538520" cy="5745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50560" y="802800"/>
            <a:ext cx="4538520" cy="2271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76"/>
              </a:spcBef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4AE590-55B6-499C-AE6A-0C545B16DC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50560" y="138240"/>
            <a:ext cx="4538520" cy="5745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50560" y="802800"/>
            <a:ext cx="4538520" cy="22719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CC117-F98C-474F-99F6-7F394743A3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50560" y="138240"/>
            <a:ext cx="4538520" cy="5745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50560" y="802800"/>
            <a:ext cx="2214720" cy="22719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576520" y="802800"/>
            <a:ext cx="2214720" cy="22719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83D5B-3575-4EED-8D1D-FB83B9DBCC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50560" y="138240"/>
            <a:ext cx="4538520" cy="5745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A351FD-F703-4B47-A0F8-2F6E2BD208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50560" y="138240"/>
            <a:ext cx="4538520" cy="2664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76"/>
              </a:spcBef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9679AC-1E5A-4CC4-9122-ED52EDFDE8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50560" y="138240"/>
            <a:ext cx="4538520" cy="5745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50560" y="802800"/>
            <a:ext cx="22147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576520" y="802800"/>
            <a:ext cx="2214720" cy="22719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50560" y="1989720"/>
            <a:ext cx="22147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93391-E3FA-4AC1-AA1E-9246D5D0DE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50560" y="138240"/>
            <a:ext cx="4538520" cy="5745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50560" y="802800"/>
            <a:ext cx="2214720" cy="22719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576520" y="802800"/>
            <a:ext cx="22147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576520" y="1989720"/>
            <a:ext cx="22147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23642-6754-4397-955E-35F4495AC4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50560" y="138240"/>
            <a:ext cx="4538520" cy="5745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50560" y="802800"/>
            <a:ext cx="22147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576520" y="802800"/>
            <a:ext cx="22147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50560" y="1989720"/>
            <a:ext cx="4538520" cy="108360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/>
          </a:bodyPr>
          <a:p>
            <a:pPr indent="0">
              <a:spcBef>
                <a:spcPts val="476"/>
              </a:spcBef>
              <a:buNone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753EF1-67FD-432B-8A88-368AEF5042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50560" y="138240"/>
            <a:ext cx="4538520" cy="5745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50560" y="802800"/>
            <a:ext cx="4538520" cy="227196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rmAutofit fontScale="93000"/>
          </a:bodyPr>
          <a:p>
            <a:pPr marL="193320" indent="-193320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1" marL="417600" indent="-160920">
              <a:spcBef>
                <a:spcPts val="476"/>
              </a:spcBef>
              <a:buClr>
                <a:srgbClr val="000000"/>
              </a:buClr>
              <a:buFont typeface="Arial"/>
              <a:buChar char="–"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2" marL="643680" indent="-129600">
              <a:spcBef>
                <a:spcPts val="476"/>
              </a:spcBef>
              <a:buClr>
                <a:srgbClr val="000000"/>
              </a:buClr>
              <a:buFont typeface="Arial"/>
              <a:buChar char="•"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3" marL="900360" indent="-128520">
              <a:spcBef>
                <a:spcPts val="476"/>
              </a:spcBef>
              <a:buClr>
                <a:srgbClr val="000000"/>
              </a:buClr>
              <a:buFont typeface="Arial"/>
              <a:buChar char="–"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4" marL="1157400" indent="-12816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5" marL="1157400" indent="-12816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lvl="6" marL="1157400" indent="-128160">
              <a:spcBef>
                <a:spcPts val="476"/>
              </a:spcBef>
              <a:buClr>
                <a:srgbClr val="000000"/>
              </a:buClr>
              <a:buFont typeface="Arial"/>
              <a:buChar char="»"/>
              <a:tabLst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50560" y="3135240"/>
            <a:ext cx="1176120" cy="23832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Autofit/>
          </a:bodyPr>
          <a:lstStyle>
            <a:lvl1pPr indent="0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  <a:defRPr b="0" lang="en-GB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722240" y="3135240"/>
            <a:ext cx="1595160" cy="23832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Autofit/>
          </a:bodyPr>
          <a:lstStyle>
            <a:lvl1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  <a:defRPr b="0" lang="en-GB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612960" y="3135240"/>
            <a:ext cx="1176120" cy="238320"/>
          </a:xfrm>
          <a:prstGeom prst="rect">
            <a:avLst/>
          </a:prstGeom>
          <a:noFill/>
          <a:ln w="0">
            <a:noFill/>
          </a:ln>
        </p:spPr>
        <p:txBody>
          <a:bodyPr lIns="55440" rIns="55440" tIns="27720" bIns="27720" anchor="t">
            <a:noAutofit/>
          </a:bodyPr>
          <a:lstStyle>
            <a:lvl1pPr indent="0" algn="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  <a:defRPr b="0" lang="en-GB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552600"/>
                <a:tab algn="l" pos="1104840"/>
                <a:tab algn="l" pos="1657440"/>
                <a:tab algn="l" pos="2209680"/>
                <a:tab algn="l" pos="2762280"/>
                <a:tab algn="l" pos="3314880"/>
                <a:tab algn="l" pos="3867120"/>
                <a:tab algn="l" pos="4419720"/>
                <a:tab algn="l" pos="4971960"/>
                <a:tab algn="l" pos="5524560"/>
                <a:tab algn="l" pos="6076800"/>
                <a:tab algn="l" pos="6629400"/>
                <a:tab algn="l" pos="7182000"/>
                <a:tab algn="l" pos="7734240"/>
                <a:tab algn="l" pos="8286840"/>
                <a:tab algn="l" pos="8839080"/>
                <a:tab algn="l" pos="9391680"/>
                <a:tab algn="l" pos="9944280"/>
                <a:tab algn="l" pos="10496520"/>
              </a:tabLst>
            </a:pPr>
            <a:fld id="{7FAB7D76-9240-4AD5-8FDD-574AD64DA211}" type="slidenum">
              <a:rPr b="0" lang="en-GB" sz="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7000" y="3014640"/>
            <a:ext cx="244440" cy="14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05840" y="28306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flipH="1" flipV="1">
            <a:off x="3908520" y="1241280"/>
            <a:ext cx="542880" cy="19080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912000">
            <a:off x="4465800" y="144252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H="1" flipV="1">
            <a:off x="4090680" y="1520640"/>
            <a:ext cx="453960" cy="12204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573800" y="1612800"/>
            <a:ext cx="403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H="1" flipV="1">
            <a:off x="4225680" y="1793520"/>
            <a:ext cx="253800" cy="2844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505760" y="179244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flipH="1" flipV="1">
            <a:off x="4482720" y="1998360"/>
            <a:ext cx="95400" cy="2052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603320" y="198432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H="1" flipV="1">
            <a:off x="4483080" y="1998360"/>
            <a:ext cx="46080" cy="10476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2131800">
            <a:off x="4519440" y="2160720"/>
            <a:ext cx="255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H="1" flipV="1">
            <a:off x="4251240" y="1993680"/>
            <a:ext cx="231840" cy="468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 flipV="1">
            <a:off x="4263840" y="2068560"/>
            <a:ext cx="122040" cy="9360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2665200">
            <a:off x="4363200" y="226512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H="1" flipV="1">
            <a:off x="4246200" y="2163240"/>
            <a:ext cx="98280" cy="9396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2658000">
            <a:off x="4326120" y="235116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H="1" flipV="1">
            <a:off x="4246200" y="2163240"/>
            <a:ext cx="4680" cy="21132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3905400">
            <a:off x="4175640" y="249264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4246560" y="2068560"/>
            <a:ext cx="17640" cy="9504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H="1" flipV="1">
            <a:off x="4251240" y="1993680"/>
            <a:ext cx="12960" cy="7452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 flipV="1">
            <a:off x="4226040" y="1793880"/>
            <a:ext cx="25200" cy="20016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 flipV="1">
            <a:off x="4090680" y="1521000"/>
            <a:ext cx="135000" cy="27288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H="1" flipV="1">
            <a:off x="3908160" y="1240920"/>
            <a:ext cx="182520" cy="27972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H="1" flipV="1">
            <a:off x="3465000" y="1120320"/>
            <a:ext cx="443160" cy="120600"/>
          </a:xfrm>
          <a:prstGeom prst="line">
            <a:avLst/>
          </a:prstGeom>
          <a:ln cap="sq" w="158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H="1" flipV="1">
            <a:off x="3644640" y="1484280"/>
            <a:ext cx="322200" cy="71424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3550800">
            <a:off x="3909960" y="230688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H="1" flipV="1">
            <a:off x="3598920" y="1871640"/>
            <a:ext cx="296640" cy="4428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2605200">
            <a:off x="3848040" y="2469960"/>
            <a:ext cx="503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H="1" flipV="1">
            <a:off x="3538080" y="2154240"/>
            <a:ext cx="297000" cy="30312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2545200">
            <a:off x="3805200" y="257976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flipH="1" flipV="1">
            <a:off x="3456000" y="2462040"/>
            <a:ext cx="309600" cy="1908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426200">
            <a:off x="3774600" y="269892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flipH="1" flipV="1">
            <a:off x="3435120" y="2606760"/>
            <a:ext cx="206280" cy="20952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2193000">
            <a:off x="3617280" y="290844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H="1" flipV="1">
            <a:off x="3367080" y="2739960"/>
            <a:ext cx="125280" cy="27144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5185200">
            <a:off x="3382560" y="313380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3273480" y="2739600"/>
            <a:ext cx="93600" cy="20628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rot="6729000">
            <a:off x="3066480" y="305784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3367080" y="2606760"/>
            <a:ext cx="68400" cy="1332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3435480" y="2462040"/>
            <a:ext cx="20520" cy="14472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3456000" y="2153880"/>
            <a:ext cx="82440" cy="3078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3538440" y="1871280"/>
            <a:ext cx="60480" cy="2826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3598920" y="1484280"/>
            <a:ext cx="46080" cy="38736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H="1" flipV="1">
            <a:off x="3465000" y="1120680"/>
            <a:ext cx="179640" cy="363600"/>
          </a:xfrm>
          <a:prstGeom prst="line">
            <a:avLst/>
          </a:prstGeom>
          <a:ln cap="sq" w="158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H="1" flipV="1">
            <a:off x="3006720" y="1006200"/>
            <a:ext cx="458640" cy="11412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flipH="1" flipV="1">
            <a:off x="3052440" y="2058480"/>
            <a:ext cx="41400" cy="45252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rot="15957000">
            <a:off x="2887920" y="271944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H="1" flipV="1">
            <a:off x="3035160" y="2641680"/>
            <a:ext cx="28800" cy="10152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rot="16200000">
            <a:off x="2876760" y="290700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2994120" y="2641680"/>
            <a:ext cx="41040" cy="1857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rot="16200000">
            <a:off x="2854080" y="294624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H="1" flipV="1">
            <a:off x="2884680" y="2400480"/>
            <a:ext cx="147960" cy="2361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H="1" flipV="1">
            <a:off x="2860200" y="2738160"/>
            <a:ext cx="1800" cy="468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rot="16200000">
            <a:off x="2744280" y="289080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flipV="1">
            <a:off x="2860560" y="2738520"/>
            <a:ext cx="1800" cy="93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rot="16200000">
            <a:off x="2692800" y="290556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mp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H="1" flipV="1">
            <a:off x="2823840" y="2541240"/>
            <a:ext cx="36360" cy="19692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flipH="1" flipV="1">
            <a:off x="2733840" y="2703600"/>
            <a:ext cx="80640" cy="12384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rot="16200000">
            <a:off x="2687760" y="293976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flipH="1" flipV="1">
            <a:off x="2712600" y="2796840"/>
            <a:ext cx="58680" cy="1206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rot="16200000">
            <a:off x="2480760" y="296136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flipV="1">
            <a:off x="2678040" y="2797200"/>
            <a:ext cx="34920" cy="921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rot="16845000">
            <a:off x="2409480" y="294624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at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flipV="1">
            <a:off x="2712960" y="2703600"/>
            <a:ext cx="20880" cy="936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H="1" flipV="1">
            <a:off x="2720880" y="2651040"/>
            <a:ext cx="12960" cy="525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flipV="1">
            <a:off x="2617920" y="2781360"/>
            <a:ext cx="1440" cy="5544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rot="16200000">
            <a:off x="2618280" y="304596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V="1">
            <a:off x="2583000" y="2781360"/>
            <a:ext cx="36360" cy="540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rot="16200000">
            <a:off x="2510280" y="304812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heep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V="1">
            <a:off x="2619360" y="2651040"/>
            <a:ext cx="101520" cy="13032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flipV="1">
            <a:off x="2720880" y="2541600"/>
            <a:ext cx="103320" cy="10944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 flipV="1">
            <a:off x="2824200" y="2398320"/>
            <a:ext cx="61920" cy="14292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flipV="1">
            <a:off x="2886120" y="2058840"/>
            <a:ext cx="166680" cy="33984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 flipV="1">
            <a:off x="3052800" y="1442520"/>
            <a:ext cx="23760" cy="6159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 flipV="1">
            <a:off x="2610000" y="1890720"/>
            <a:ext cx="209520" cy="6588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rot="17353200">
            <a:off x="2414520" y="2554200"/>
            <a:ext cx="32976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 flipV="1">
            <a:off x="2454120" y="2174760"/>
            <a:ext cx="68400" cy="64152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rot="16200000">
            <a:off x="2220120" y="3013560"/>
            <a:ext cx="439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 flipH="1" flipV="1">
            <a:off x="2227320" y="2525760"/>
            <a:ext cx="31680" cy="4665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rot="15894600">
            <a:off x="2122920" y="314100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055960" y="2822400"/>
            <a:ext cx="1440" cy="18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rot="16840200">
            <a:off x="1785240" y="3038040"/>
            <a:ext cx="509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eabream TLR9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flipV="1">
            <a:off x="2046240" y="2822040"/>
            <a:ext cx="9720" cy="1116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 rot="18241800">
            <a:off x="1618920" y="3012480"/>
            <a:ext cx="509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Seabream TLR9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 flipV="1">
            <a:off x="2055960" y="2525760"/>
            <a:ext cx="171360" cy="29664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flipV="1">
            <a:off x="2227320" y="2174400"/>
            <a:ext cx="295200" cy="35100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flipV="1">
            <a:off x="2522520" y="1890360"/>
            <a:ext cx="297000" cy="28404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flipV="1">
            <a:off x="2819520" y="1442880"/>
            <a:ext cx="257040" cy="44784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flipH="1" flipV="1">
            <a:off x="3006720" y="1006560"/>
            <a:ext cx="69840" cy="436320"/>
          </a:xfrm>
          <a:prstGeom prst="line">
            <a:avLst/>
          </a:prstGeom>
          <a:ln cap="sq" w="15840">
            <a:solidFill>
              <a:srgbClr val="ff99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H="1" flipV="1">
            <a:off x="2445840" y="658800"/>
            <a:ext cx="560520" cy="34776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flipV="1">
            <a:off x="1982880" y="2041560"/>
            <a:ext cx="95040" cy="48744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rot="17296200">
            <a:off x="1668960" y="2748960"/>
            <a:ext cx="503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flipV="1">
            <a:off x="1893960" y="2220840"/>
            <a:ext cx="12600" cy="41904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rot="17089800">
            <a:off x="1636560" y="2814120"/>
            <a:ext cx="403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flipH="1" flipV="1">
            <a:off x="1731960" y="2619000"/>
            <a:ext cx="31680" cy="9540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rot="17090400">
            <a:off x="1561680" y="286416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flipV="1">
            <a:off x="1706400" y="2619000"/>
            <a:ext cx="25560" cy="8892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rot="17146200">
            <a:off x="1541160" y="282564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flipH="1" flipV="1">
            <a:off x="1663560" y="2453760"/>
            <a:ext cx="68400" cy="16524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flipH="1" flipV="1">
            <a:off x="1595520" y="2530080"/>
            <a:ext cx="22320" cy="18900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rot="16726800">
            <a:off x="1446480" y="284436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flipV="1">
            <a:off x="1522440" y="2577600"/>
            <a:ext cx="17280" cy="18108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rot="16399800">
            <a:off x="1366200" y="287532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flipH="1" flipV="1">
            <a:off x="1428840" y="2701800"/>
            <a:ext cx="1440" cy="648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rot="16200000">
            <a:off x="1263240" y="287172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flipV="1">
            <a:off x="1417680" y="2701800"/>
            <a:ext cx="11160" cy="1584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rot="17620200">
            <a:off x="1153080" y="285300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mp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 flipV="1">
            <a:off x="1428840" y="2577960"/>
            <a:ext cx="110880" cy="12384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V="1">
            <a:off x="1539720" y="2530440"/>
            <a:ext cx="55800" cy="4752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V="1">
            <a:off x="1595520" y="2454120"/>
            <a:ext cx="68040" cy="7632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V="1">
            <a:off x="1663560" y="2220840"/>
            <a:ext cx="243000" cy="23328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flipV="1">
            <a:off x="1906560" y="2041560"/>
            <a:ext cx="171360" cy="17928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2077920" y="1672920"/>
            <a:ext cx="33480" cy="36828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1635120" y="1979280"/>
            <a:ext cx="257040" cy="34452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rot="18522600">
            <a:off x="1310040" y="2359800"/>
            <a:ext cx="26604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1539720" y="1979640"/>
            <a:ext cx="352440" cy="40968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rot="18626400">
            <a:off x="1370520" y="242496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flipV="1">
            <a:off x="1892160" y="1672920"/>
            <a:ext cx="219240" cy="30636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 flipV="1">
            <a:off x="2111400" y="1112400"/>
            <a:ext cx="173160" cy="56052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flipV="1">
            <a:off x="1293840" y="2063520"/>
            <a:ext cx="158760" cy="46836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 rot="17050200">
            <a:off x="1041120" y="2702520"/>
            <a:ext cx="403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 flipH="1" flipV="1">
            <a:off x="1176480" y="2252160"/>
            <a:ext cx="1440" cy="32868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 rot="16966200">
            <a:off x="898560" y="278244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 flipH="1" flipV="1">
            <a:off x="933480" y="2490840"/>
            <a:ext cx="71280" cy="19368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 rot="16498200">
            <a:off x="812520" y="284580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V="1">
            <a:off x="830160" y="2490840"/>
            <a:ext cx="103320" cy="24120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 rot="17446800">
            <a:off x="649440" y="284148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flipH="1" flipV="1">
            <a:off x="920520" y="2363400"/>
            <a:ext cx="12600" cy="12708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 flipV="1">
            <a:off x="671400" y="2480760"/>
            <a:ext cx="41400" cy="12708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rot="17553600">
            <a:off x="412920" y="274968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 flipV="1">
            <a:off x="577800" y="2481120"/>
            <a:ext cx="135000" cy="7488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rot="20286600">
            <a:off x="306000" y="257472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 flipV="1">
            <a:off x="712800" y="2363760"/>
            <a:ext cx="208080" cy="11736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flipV="1">
            <a:off x="920880" y="2252160"/>
            <a:ext cx="255600" cy="11124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flipV="1">
            <a:off x="1176480" y="2063880"/>
            <a:ext cx="276120" cy="18864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flipV="1">
            <a:off x="1455480" y="1821960"/>
            <a:ext cx="118080" cy="23364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flipV="1">
            <a:off x="971640" y="2088720"/>
            <a:ext cx="183960" cy="11124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 rot="20101200">
            <a:off x="574200" y="2270160"/>
            <a:ext cx="415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laev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V="1">
            <a:off x="987480" y="2088720"/>
            <a:ext cx="168120" cy="6372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rot="20267400">
            <a:off x="491040" y="2217240"/>
            <a:ext cx="503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 flipV="1">
            <a:off x="1155600" y="1812600"/>
            <a:ext cx="416160" cy="27612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flipV="1">
            <a:off x="1571760" y="1449360"/>
            <a:ext cx="225360" cy="36360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 flipV="1">
            <a:off x="1030320" y="1956960"/>
            <a:ext cx="104760" cy="9540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 rot="20301600">
            <a:off x="484560" y="2142720"/>
            <a:ext cx="5662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inbow trout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flipV="1">
            <a:off x="1020600" y="1956960"/>
            <a:ext cx="114480" cy="8100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 rot="20336400">
            <a:off x="416160" y="2101680"/>
            <a:ext cx="6087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inbow trout TLR5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 flipV="1">
            <a:off x="1135080" y="1646280"/>
            <a:ext cx="349200" cy="31104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 flipV="1">
            <a:off x="814680" y="1749600"/>
            <a:ext cx="329400" cy="20592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 rot="19950000">
            <a:off x="505440" y="200160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flipV="1">
            <a:off x="786600" y="1751040"/>
            <a:ext cx="351000" cy="14220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 rot="20124600">
            <a:off x="432720" y="1934640"/>
            <a:ext cx="361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5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 flipV="1">
            <a:off x="1150560" y="1646640"/>
            <a:ext cx="329400" cy="9936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 flipV="1">
            <a:off x="1484280" y="1449000"/>
            <a:ext cx="312840" cy="19692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 flipV="1">
            <a:off x="1797120" y="1112400"/>
            <a:ext cx="487440" cy="336600"/>
          </a:xfrm>
          <a:prstGeom prst="line">
            <a:avLst/>
          </a:prstGeom>
          <a:ln cap="sq" w="158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 flipV="1">
            <a:off x="2284560" y="658440"/>
            <a:ext cx="161640" cy="45396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 flipH="1" flipV="1">
            <a:off x="2259000" y="198000"/>
            <a:ext cx="187200" cy="4604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1795320" y="61920"/>
            <a:ext cx="463680" cy="1364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4365360" y="19051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4167000" y="21337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4177800" y="20336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4134960" y="19494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4105080" y="17604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4009680" y="15033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3798360" y="12463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3352320" y="11253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3555720" y="14526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3516120" y="18352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3417480" y="21178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3330360" y="24242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3344400" y="25639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3271320" y="27082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2892240" y="10065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2914200" y="26067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2933280" y="20019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2763360" y="23623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2734920" y="24890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2855520" y="26622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2657160" y="25909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2742840" y="26496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2612520" y="27543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2541240" y="27367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2734920" y="18352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2406240" y="21114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2103120" y="24829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1949040" y="27543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2334960" y="6238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2203200" y="10555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1736280" y="25686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1314000" y="26398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1607760" y="25146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1677600" y="24210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1915920" y="22082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2085480" y="19987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2118960" y="16318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1817280" y="19065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1725120" y="13510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1045800" y="18669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1072800" y="20066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1136160" y="1654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1445760" y="15541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1503000" y="17398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717120" y="24829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944280" y="2446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937800" y="23464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1185480" y="22431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1458720" y="20430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8T11:27:04Z</dcterms:created>
  <dc:creator>Nicholas David Temperley</dc:creator>
  <dc:description/>
  <dc:language>en-US</dc:language>
  <cp:lastModifiedBy>Nicholas David Temperley</cp:lastModifiedBy>
  <dcterms:modified xsi:type="dcterms:W3CDTF">2008-01-31T15:39:58Z</dcterms:modified>
  <cp:revision>39</cp:revision>
  <dc:subject/>
  <dc:title>Slide 1</dc:title>
</cp:coreProperties>
</file>